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69" r:id="rId1"/>
    <p:sldMasterId id="2147483670" r:id="rId2"/>
  </p:sldMasterIdLst>
  <p:notesMasterIdLst>
    <p:notesMasterId r:id="rId6"/>
  </p:notesMasterIdLst>
  <p:sldIdLst>
    <p:sldId id="256" r:id="rId3"/>
    <p:sldId id="257" r:id="rId4"/>
    <p:sldId id="258" r:id="rId5"/>
  </p:sldIdLst>
  <p:sldSz cx="9144000" cy="5143500" type="screen16x9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18" d="100"/>
          <a:sy n="118" d="100"/>
        </p:scale>
        <p:origin x="370" y="86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Google Shape;92;g4040527c5e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3" name="Google Shape;93;g4040527c5e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Google Shape;99;g4040527c5e_0_4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00" name="Google Shape;100;g4040527c5e_0_4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endParaRPr sz="11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spcFirstLastPara="1" wrap="square" lIns="91425" tIns="91425" rIns="91425" bIns="91425" anchor="b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6" name="Google Shape;56;p1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42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Font typeface="Arial"/>
              <a:buChar char="●"/>
              <a:defRPr sz="18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■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●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■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●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17500" algn="l" rtl="0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Clr>
                <a:schemeClr val="dk2"/>
              </a:buClr>
              <a:buSzPts val="1400"/>
              <a:buFont typeface="Arial"/>
              <a:buChar char="■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7" name="Google Shape;57;p1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5"/>
          <p:cNvSpPr txBox="1">
            <a:spLocks noGrp="1"/>
          </p:cNvSpPr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Arial"/>
              <a:buNone/>
              <a:defRPr sz="3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Arial"/>
              <a:buNone/>
              <a:defRPr sz="3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Arial"/>
              <a:buNone/>
              <a:defRPr sz="3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Arial"/>
              <a:buNone/>
              <a:defRPr sz="3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Arial"/>
              <a:buNone/>
              <a:defRPr sz="3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Arial"/>
              <a:buNone/>
              <a:defRPr sz="3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Arial"/>
              <a:buNone/>
              <a:defRPr sz="3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Arial"/>
              <a:buNone/>
              <a:defRPr sz="3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Arial"/>
              <a:buNone/>
              <a:defRPr sz="3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0" name="Google Shape;60;p1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3" name="Google Shape;63;p16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●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048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200"/>
              <a:buFont typeface="Arial"/>
              <a:buChar char="○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048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200"/>
              <a:buFont typeface="Arial"/>
              <a:buChar char="■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048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200"/>
              <a:buFont typeface="Arial"/>
              <a:buChar char="●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048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200"/>
              <a:buFont typeface="Arial"/>
              <a:buChar char="○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048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200"/>
              <a:buFont typeface="Arial"/>
              <a:buChar char="■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048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200"/>
              <a:buFont typeface="Arial"/>
              <a:buChar char="●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048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200"/>
              <a:buFont typeface="Arial"/>
              <a:buChar char="○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04800" algn="l" rtl="0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Clr>
                <a:schemeClr val="dk2"/>
              </a:buClr>
              <a:buSzPts val="1200"/>
              <a:buFont typeface="Arial"/>
              <a:buChar char="■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4" name="Google Shape;64;p16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●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048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200"/>
              <a:buFont typeface="Arial"/>
              <a:buChar char="○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048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200"/>
              <a:buFont typeface="Arial"/>
              <a:buChar char="■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048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200"/>
              <a:buFont typeface="Arial"/>
              <a:buChar char="●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048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200"/>
              <a:buFont typeface="Arial"/>
              <a:buChar char="○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048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200"/>
              <a:buFont typeface="Arial"/>
              <a:buChar char="■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048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200"/>
              <a:buFont typeface="Arial"/>
              <a:buChar char="●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048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200"/>
              <a:buFont typeface="Arial"/>
              <a:buChar char="○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04800" algn="l" rtl="0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Clr>
                <a:schemeClr val="dk2"/>
              </a:buClr>
              <a:buSzPts val="1200"/>
              <a:buFont typeface="Arial"/>
              <a:buChar char="■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5" name="Google Shape;65;p1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Google Shape;67;p17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8" name="Google Shape;68;p1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Google Shape;70;p18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1" name="Google Shape;71;p18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048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200"/>
              <a:buFont typeface="Arial"/>
              <a:buChar char="●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048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200"/>
              <a:buFont typeface="Arial"/>
              <a:buChar char="○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048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200"/>
              <a:buFont typeface="Arial"/>
              <a:buChar char="■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048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200"/>
              <a:buFont typeface="Arial"/>
              <a:buChar char="●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048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200"/>
              <a:buFont typeface="Arial"/>
              <a:buChar char="○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048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200"/>
              <a:buFont typeface="Arial"/>
              <a:buChar char="■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048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200"/>
              <a:buFont typeface="Arial"/>
              <a:buChar char="●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048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200"/>
              <a:buFont typeface="Arial"/>
              <a:buChar char="○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04800" algn="l" rtl="0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Clr>
                <a:schemeClr val="dk2"/>
              </a:buClr>
              <a:buSzPts val="1200"/>
              <a:buFont typeface="Arial"/>
              <a:buChar char="■"/>
              <a:defRPr sz="12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2" name="Google Shape;72;p1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Google Shape;74;p19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800"/>
              <a:buFont typeface="Arial"/>
              <a:buNone/>
              <a:defRPr sz="4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800"/>
              <a:buFont typeface="Arial"/>
              <a:buNone/>
              <a:defRPr sz="4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800"/>
              <a:buFont typeface="Arial"/>
              <a:buNone/>
              <a:defRPr sz="4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800"/>
              <a:buFont typeface="Arial"/>
              <a:buNone/>
              <a:defRPr sz="4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800"/>
              <a:buFont typeface="Arial"/>
              <a:buNone/>
              <a:defRPr sz="4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800"/>
              <a:buFont typeface="Arial"/>
              <a:buNone/>
              <a:defRPr sz="4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800"/>
              <a:buFont typeface="Arial"/>
              <a:buNone/>
              <a:defRPr sz="4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800"/>
              <a:buFont typeface="Arial"/>
              <a:buNone/>
              <a:defRPr sz="4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800"/>
              <a:buFont typeface="Arial"/>
              <a:buNone/>
              <a:defRPr sz="4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5" name="Google Shape;75;p1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Google Shape;77;p20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8" name="Google Shape;78;p20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200"/>
              <a:buFont typeface="Arial"/>
              <a:buNone/>
              <a:defRPr sz="4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200"/>
              <a:buFont typeface="Arial"/>
              <a:buNone/>
              <a:defRPr sz="4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200"/>
              <a:buFont typeface="Arial"/>
              <a:buNone/>
              <a:defRPr sz="4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200"/>
              <a:buFont typeface="Arial"/>
              <a:buNone/>
              <a:defRPr sz="4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200"/>
              <a:buFont typeface="Arial"/>
              <a:buNone/>
              <a:defRPr sz="4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200"/>
              <a:buFont typeface="Arial"/>
              <a:buNone/>
              <a:defRPr sz="4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200"/>
              <a:buFont typeface="Arial"/>
              <a:buNone/>
              <a:defRPr sz="4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200"/>
              <a:buFont typeface="Arial"/>
              <a:buNone/>
              <a:defRPr sz="4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200"/>
              <a:buFont typeface="Arial"/>
              <a:buNone/>
              <a:defRPr sz="4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9" name="Google Shape;79;p20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0" name="Google Shape;80;p20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L="457200" marR="0" lvl="0" indent="-342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Font typeface="Arial"/>
              <a:buChar char="●"/>
              <a:defRPr sz="18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■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●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■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●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17500" algn="l" rtl="0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Clr>
                <a:schemeClr val="dk2"/>
              </a:buClr>
              <a:buSzPts val="1400"/>
              <a:buFont typeface="Arial"/>
              <a:buChar char="■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1" name="Google Shape;81;p2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Google Shape;83;p21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</a:lstStyle>
          <a:p>
            <a:endParaRPr/>
          </a:p>
        </p:txBody>
      </p:sp>
      <p:sp>
        <p:nvSpPr>
          <p:cNvPr id="84" name="Google Shape;84;p2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spcFirstLastPara="1" wrap="square" lIns="91425" tIns="91425" rIns="91425" bIns="91425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Google Shape;86;p22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0"/>
              <a:buFont typeface="Arial"/>
              <a:buNone/>
              <a:defRPr sz="1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0"/>
              <a:buFont typeface="Arial"/>
              <a:buNone/>
              <a:defRPr sz="1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0"/>
              <a:buFont typeface="Arial"/>
              <a:buNone/>
              <a:defRPr sz="1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0"/>
              <a:buFont typeface="Arial"/>
              <a:buNone/>
              <a:defRPr sz="1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0"/>
              <a:buFont typeface="Arial"/>
              <a:buNone/>
              <a:defRPr sz="1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0"/>
              <a:buFont typeface="Arial"/>
              <a:buNone/>
              <a:defRPr sz="1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0"/>
              <a:buFont typeface="Arial"/>
              <a:buNone/>
              <a:defRPr sz="1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0"/>
              <a:buFont typeface="Arial"/>
              <a:buNone/>
              <a:defRPr sz="1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0"/>
              <a:buFont typeface="Arial"/>
              <a:buNone/>
              <a:defRPr sz="1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r>
              <a:t>xx%</a:t>
            </a:r>
          </a:p>
        </p:txBody>
      </p:sp>
      <p:sp>
        <p:nvSpPr>
          <p:cNvPr id="87" name="Google Shape;87;p22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42900" algn="ctr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Font typeface="Arial"/>
              <a:buChar char="●"/>
              <a:defRPr sz="18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17500" algn="ctr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17500" algn="ctr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■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17500" algn="ctr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●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17500" algn="ctr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17500" algn="ctr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■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17500" algn="ctr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●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17500" algn="ctr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17500" algn="ctr" rtl="0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Clr>
                <a:schemeClr val="dk2"/>
              </a:buClr>
              <a:buSzPts val="1400"/>
              <a:buFont typeface="Arial"/>
              <a:buChar char="■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8" name="Google Shape;88;p2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Google Shape;90;p2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/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/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/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/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theme" Target="../theme/theme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3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2" name="Google Shape;52;p13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42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Font typeface="Arial"/>
              <a:buChar char="●"/>
              <a:defRPr sz="18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■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●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■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●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1750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17500" algn="l" rtl="0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Clr>
                <a:schemeClr val="dk2"/>
              </a:buClr>
              <a:buSzPts val="1400"/>
              <a:buFont typeface="Arial"/>
              <a:buChar char="■"/>
              <a:defRPr sz="1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3" name="Google Shape;53;p1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9" r:id="rId1"/>
    <p:sldLayoutId id="2147483660" r:id="rId2"/>
    <p:sldLayoutId id="2147483661" r:id="rId3"/>
    <p:sldLayoutId id="2147483662" r:id="rId4"/>
    <p:sldLayoutId id="2147483663" r:id="rId5"/>
    <p:sldLayoutId id="2147483664" r:id="rId6"/>
    <p:sldLayoutId id="2147483665" r:id="rId7"/>
    <p:sldLayoutId id="2147483666" r:id="rId8"/>
    <p:sldLayoutId id="2147483667" r:id="rId9"/>
    <p:sldLayoutId id="2147483668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5" name="Google Shape;95;p24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592525" y="1848900"/>
            <a:ext cx="5490453" cy="3257500"/>
          </a:xfrm>
          <a:prstGeom prst="rect">
            <a:avLst/>
          </a:prstGeom>
          <a:noFill/>
          <a:ln>
            <a:noFill/>
          </a:ln>
        </p:spPr>
      </p:pic>
      <p:sp>
        <p:nvSpPr>
          <p:cNvPr id="96" name="Google Shape;96;p24"/>
          <p:cNvSpPr txBox="1"/>
          <p:nvPr/>
        </p:nvSpPr>
        <p:spPr>
          <a:xfrm>
            <a:off x="5897625" y="2212550"/>
            <a:ext cx="2969400" cy="253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dirty="0"/>
              <a:t>Figure 1. Quality checking for genomic contamination using primers spanning an intron region and targeting a lncRNA </a:t>
            </a:r>
            <a:r>
              <a:rPr lang="en-US" sz="1000" dirty="0"/>
              <a:t>with expression in</a:t>
            </a:r>
            <a:r>
              <a:rPr lang="en" sz="1000" dirty="0"/>
              <a:t> adipose </a:t>
            </a:r>
            <a:r>
              <a:rPr lang="en-US" sz="1000" dirty="0"/>
              <a:t>and liver</a:t>
            </a:r>
            <a:r>
              <a:rPr lang="en" sz="1000" dirty="0"/>
              <a:t> tissue in chicken. cDNA transcripts were transcribed from total RNA with reverse transcriptase for all 8 tissues in chicken  studied in this paper. PCR templates include genomic DNA (G), negative control (N), and the cDNA templates of the RNA from the 8 tissues. Lanes are loaded in the following order:  Ladder (L), genomic DNA (G), adipose </a:t>
            </a:r>
            <a:r>
              <a:rPr lang="en" sz="1000" dirty="0">
                <a:solidFill>
                  <a:schemeClr val="dk1"/>
                </a:solidFill>
              </a:rPr>
              <a:t>(1) </a:t>
            </a:r>
            <a:r>
              <a:rPr lang="en" sz="1000" dirty="0"/>
              <a:t>, cerebellum </a:t>
            </a:r>
            <a:r>
              <a:rPr lang="en" sz="1000" dirty="0">
                <a:solidFill>
                  <a:schemeClr val="dk1"/>
                </a:solidFill>
              </a:rPr>
              <a:t>(2)</a:t>
            </a:r>
            <a:r>
              <a:rPr lang="en" sz="1000" dirty="0"/>
              <a:t>, cortex </a:t>
            </a:r>
            <a:r>
              <a:rPr lang="en" sz="1000" dirty="0">
                <a:solidFill>
                  <a:schemeClr val="dk1"/>
                </a:solidFill>
              </a:rPr>
              <a:t>(3) </a:t>
            </a:r>
            <a:r>
              <a:rPr lang="en" sz="1000" dirty="0"/>
              <a:t>, hypothalamus </a:t>
            </a:r>
            <a:r>
              <a:rPr lang="en" sz="1000" dirty="0">
                <a:solidFill>
                  <a:schemeClr val="dk1"/>
                </a:solidFill>
              </a:rPr>
              <a:t>(4)</a:t>
            </a:r>
            <a:r>
              <a:rPr lang="en" sz="1000" dirty="0"/>
              <a:t>, liver (5), lung (6), muscle (7), and spleen (8). </a:t>
            </a:r>
            <a:endParaRPr sz="1000" dirty="0"/>
          </a:p>
        </p:txBody>
      </p:sp>
      <p:pic>
        <p:nvPicPr>
          <p:cNvPr id="97" name="Google Shape;97;p24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194700" y="69413"/>
            <a:ext cx="6572250" cy="214312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" name="Google Shape;102;p25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458175" y="1406350"/>
            <a:ext cx="5306747" cy="3737150"/>
          </a:xfrm>
          <a:prstGeom prst="rect">
            <a:avLst/>
          </a:prstGeom>
          <a:noFill/>
          <a:ln>
            <a:noFill/>
          </a:ln>
        </p:spPr>
      </p:pic>
      <p:pic>
        <p:nvPicPr>
          <p:cNvPr id="103" name="Google Shape;103;p25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366825" y="118475"/>
            <a:ext cx="6410325" cy="2009775"/>
          </a:xfrm>
          <a:prstGeom prst="rect">
            <a:avLst/>
          </a:prstGeom>
          <a:noFill/>
          <a:ln>
            <a:noFill/>
          </a:ln>
        </p:spPr>
      </p:pic>
      <p:sp>
        <p:nvSpPr>
          <p:cNvPr id="104" name="Google Shape;104;p25"/>
          <p:cNvSpPr txBox="1"/>
          <p:nvPr/>
        </p:nvSpPr>
        <p:spPr>
          <a:xfrm>
            <a:off x="5848075" y="1866725"/>
            <a:ext cx="3000000" cy="300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dirty="0">
                <a:solidFill>
                  <a:schemeClr val="dk1"/>
                </a:solidFill>
              </a:rPr>
              <a:t>Figure 2. Quality checking for genomic contamination using primers spanning an intron region and targeting a lncRNA </a:t>
            </a:r>
            <a:r>
              <a:rPr lang="en-US" sz="1000" dirty="0">
                <a:solidFill>
                  <a:schemeClr val="dk1"/>
                </a:solidFill>
              </a:rPr>
              <a:t>with strong expression in</a:t>
            </a:r>
            <a:r>
              <a:rPr lang="en" sz="1000" dirty="0">
                <a:solidFill>
                  <a:schemeClr val="dk1"/>
                </a:solidFill>
              </a:rPr>
              <a:t> adipose tissue in pig. cDNA transcripts were transcribed from total RNA with reverse transcriptase for all 8 tissues in pig studied in this paper. PCR templates include genomic DNA (G), negative control (N), and the cDNA templates of the RNA from the 8 tissues. Lanes are loaded in the following order:  Ladder (L), genomic DNA (G), adipose (1) , cerebellum (2), cortex (3) , hypothalamus (4), liver (5), lung (6), muscle (7), and spleen (8). </a:t>
            </a:r>
            <a:endParaRPr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61B16DBE-ACD3-4A16-873D-D55760D55AD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67466316"/>
              </p:ext>
            </p:extLst>
          </p:nvPr>
        </p:nvGraphicFramePr>
        <p:xfrm>
          <a:off x="461119" y="359126"/>
          <a:ext cx="6159500" cy="891540"/>
        </p:xfrm>
        <a:graphic>
          <a:graphicData uri="http://schemas.openxmlformats.org/drawingml/2006/table">
            <a:tbl>
              <a:tblPr/>
              <a:tblGrid>
                <a:gridCol w="1193800">
                  <a:extLst>
                    <a:ext uri="{9D8B030D-6E8A-4147-A177-3AD203B41FA5}">
                      <a16:colId xmlns:a16="http://schemas.microsoft.com/office/drawing/2014/main" val="2912102720"/>
                    </a:ext>
                  </a:extLst>
                </a:gridCol>
                <a:gridCol w="1193800">
                  <a:extLst>
                    <a:ext uri="{9D8B030D-6E8A-4147-A177-3AD203B41FA5}">
                      <a16:colId xmlns:a16="http://schemas.microsoft.com/office/drawing/2014/main" val="3464048994"/>
                    </a:ext>
                  </a:extLst>
                </a:gridCol>
                <a:gridCol w="1892300">
                  <a:extLst>
                    <a:ext uri="{9D8B030D-6E8A-4147-A177-3AD203B41FA5}">
                      <a16:colId xmlns:a16="http://schemas.microsoft.com/office/drawing/2014/main" val="2245622570"/>
                    </a:ext>
                  </a:extLst>
                </a:gridCol>
                <a:gridCol w="1879600">
                  <a:extLst>
                    <a:ext uri="{9D8B030D-6E8A-4147-A177-3AD203B41FA5}">
                      <a16:colId xmlns:a16="http://schemas.microsoft.com/office/drawing/2014/main" val="2709232305"/>
                    </a:ext>
                  </a:extLst>
                </a:gridCol>
              </a:tblGrid>
              <a:tr h="182880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ble 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8401967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pecies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cript Target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orward primer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verse primer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99947227"/>
                  </a:ext>
                </a:extLst>
              </a:tr>
              <a:tr h="3429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icken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ONS_0011026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CTGCAGATACCAAGGCT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ATCAAAGTCCACCACCAG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040550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g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ONS_0003393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ACGAGCAGTAGATTGGGA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ACCTGGAATGCATGGAGTG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299237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24537884"/>
      </p:ext>
    </p:extLst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FFAB40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FFAB40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72</Words>
  <Application>Microsoft Office PowerPoint</Application>
  <PresentationFormat>On-screen Show (16:9)</PresentationFormat>
  <Paragraphs>15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Simple Light</vt:lpstr>
      <vt:lpstr>Simple Light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ckern</cp:lastModifiedBy>
  <cp:revision>2</cp:revision>
  <dcterms:modified xsi:type="dcterms:W3CDTF">2018-08-14T17:07:54Z</dcterms:modified>
</cp:coreProperties>
</file>